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8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71BA9C5-6AE4-FCBC-BBC0-723EB22DFE5D}" name="平田　理紗" initials="平田　理紗" userId="S::ss4889@cc.saga-u.ac.jp::0859a0fb-d3bc-4737-a683-3c17343421bb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3132" y="54"/>
      </p:cViewPr>
      <p:guideLst>
        <p:guide orient="horz" pos="298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go Masaki" userId="e657396fbe83e9a5" providerId="LiveId" clId="{94CA59C1-2C2D-46A7-9BEC-DCD3D5AE65BC}"/>
    <pc:docChg chg="">
      <pc:chgData name="Tago Masaki" userId="e657396fbe83e9a5" providerId="LiveId" clId="{94CA59C1-2C2D-46A7-9BEC-DCD3D5AE65BC}" dt="2022-01-22T09:47:14.259" v="1"/>
      <pc:docMkLst>
        <pc:docMk/>
      </pc:docMkLst>
      <pc:sldChg chg="delCm modCm">
        <pc:chgData name="Tago Masaki" userId="e657396fbe83e9a5" providerId="LiveId" clId="{94CA59C1-2C2D-46A7-9BEC-DCD3D5AE65BC}" dt="2022-01-22T09:47:14.259" v="1"/>
        <pc:sldMkLst>
          <pc:docMk/>
          <pc:sldMk cId="1075599517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3088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0932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9779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549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6774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875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063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680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43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5567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80541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22E8DF-4446-4807-AFA0-6BEE11E1DAA8}" type="datetimeFigureOut">
              <a:rPr kumimoji="1" lang="ja-JP" altLang="en-US" smtClean="0"/>
              <a:t>2022/1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3A6751-C192-49F5-BC8B-ADA135A9060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72895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tagomas@cc.saga-u.ac.jp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A3856C1-C5E4-416D-B17A-E5A5404E6E02}"/>
              </a:ext>
            </a:extLst>
          </p:cNvPr>
          <p:cNvSpPr txBox="1"/>
          <p:nvPr/>
        </p:nvSpPr>
        <p:spPr>
          <a:xfrm>
            <a:off x="462222" y="1086660"/>
            <a:ext cx="5933555" cy="63146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xternal validation of a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new predictive model for falls among inpatients using the official Japanese ADL scale,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edriddenness</a:t>
            </a:r>
            <a:r>
              <a:rPr lang="en-US" altLang="ja-JP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ranks: A double-centered prospective cohort study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ki Tago, 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*; Naoko E.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Katsuk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Eij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Nakatani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,3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Midori Tokushim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Akiko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ogomor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Kazumi Mori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Shun Yamashit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Yoshimasa Oda, M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; Shu-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ch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Yamashita, MD, PhD</a:t>
            </a: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Saga University Hospital, Sag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aduate School of Public Health, Shizuoka Graduate University of Public Health, Shizuok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ranslational Research Center for Medical Innovation, Foundation for Biomedical Research and Innovation at Kobe, Hyogo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kern="100" baseline="300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epartment of General Medicine,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Yuai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-Kai Foundation and Oda Hospital, Saga, Japan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orresponding author: 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asaki Tago, Department of General Medicine, Saga University Hospital, Saga, Japan. Address: 5-1-1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abeshima</a:t>
            </a:r>
            <a:r>
              <a:rPr lang="en-US" altLang="ja-JP" sz="12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Saga, 849-8501 Japan. TEL: +81-952-34-3238. FAX: +81-952-34-2029. E-mail: </a:t>
            </a:r>
            <a:r>
              <a:rPr lang="en-US" altLang="ja-JP" sz="1200" u="sng" kern="100" dirty="0">
                <a:solidFill>
                  <a:srgbClr val="0563C1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  <a:hlinkClick r:id="rId2"/>
              </a:rPr>
              <a:t>tagomas@cc.saga-u.ac.jp</a:t>
            </a:r>
            <a:endParaRPr lang="ja-JP" altLang="ja-JP" sz="1200" kern="100" dirty="0"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9534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1780E909-22C3-4E26-886C-90C92950440F}"/>
              </a:ext>
            </a:extLst>
          </p:cNvPr>
          <p:cNvCxnSpPr>
            <a:cxnSpLocks/>
          </p:cNvCxnSpPr>
          <p:nvPr/>
        </p:nvCxnSpPr>
        <p:spPr>
          <a:xfrm>
            <a:off x="-704386" y="779639"/>
            <a:ext cx="0" cy="8925615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CBAF0ED0-1A2D-426E-BD44-6216B4BCC32C}"/>
              </a:ext>
            </a:extLst>
          </p:cNvPr>
          <p:cNvSpPr txBox="1"/>
          <p:nvPr/>
        </p:nvSpPr>
        <p:spPr>
          <a:xfrm>
            <a:off x="290513" y="166518"/>
            <a:ext cx="4762500" cy="4047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7, Figure. The results of the analysis</a:t>
            </a:r>
            <a:r>
              <a:rPr lang="ja-JP" altLang="en-US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y age</a:t>
            </a:r>
            <a:r>
              <a:rPr lang="ja-JP" altLang="en-US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b="1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roup</a:t>
            </a:r>
            <a:endParaRPr lang="ja-JP" altLang="ja-JP" sz="1050" b="1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DEBB224B-0F5A-4935-881B-15738BD8A6BF}"/>
              </a:ext>
            </a:extLst>
          </p:cNvPr>
          <p:cNvSpPr txBox="1"/>
          <p:nvPr/>
        </p:nvSpPr>
        <p:spPr>
          <a:xfrm>
            <a:off x="1377327" y="1310645"/>
            <a:ext cx="11384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Age</a:t>
            </a:r>
            <a:r>
              <a:rPr kumimoji="1" lang="ja-JP" altLang="en-US" sz="1400" b="1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 </a:t>
            </a:r>
            <a:r>
              <a:rPr kumimoji="1" lang="en-US" altLang="ja-JP" sz="1400" b="1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(Years)</a:t>
            </a:r>
            <a:endParaRPr kumimoji="1" lang="ja-JP" altLang="en-US" sz="1400" b="1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4C65C82-8E89-4FDC-998D-ECB74319AF8C}"/>
              </a:ext>
            </a:extLst>
          </p:cNvPr>
          <p:cNvSpPr txBox="1"/>
          <p:nvPr/>
        </p:nvSpPr>
        <p:spPr>
          <a:xfrm>
            <a:off x="2665700" y="127382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0.4</a:t>
            </a:r>
            <a:endParaRPr kumimoji="1" lang="ja-JP" altLang="en-US" sz="14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377B3FB-A037-4558-A761-9A31EA64A25C}"/>
              </a:ext>
            </a:extLst>
          </p:cNvPr>
          <p:cNvSpPr txBox="1"/>
          <p:nvPr/>
        </p:nvSpPr>
        <p:spPr>
          <a:xfrm>
            <a:off x="3183860" y="1273818"/>
            <a:ext cx="4331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0.5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F191A01-07D7-4CE8-9B1C-F116EB9AA622}"/>
              </a:ext>
            </a:extLst>
          </p:cNvPr>
          <p:cNvSpPr txBox="1"/>
          <p:nvPr/>
        </p:nvSpPr>
        <p:spPr>
          <a:xfrm>
            <a:off x="3727754" y="1273820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0.6</a:t>
            </a:r>
            <a:endParaRPr kumimoji="1" lang="ja-JP" altLang="en-US" sz="14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52CAED0-CDE3-44E7-8131-6F575FFF32F3}"/>
              </a:ext>
            </a:extLst>
          </p:cNvPr>
          <p:cNvSpPr txBox="1"/>
          <p:nvPr/>
        </p:nvSpPr>
        <p:spPr>
          <a:xfrm>
            <a:off x="4264966" y="1275313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0.7</a:t>
            </a:r>
            <a:endParaRPr kumimoji="1" lang="ja-JP" altLang="en-US" sz="14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226C852-6272-4F7E-8A9C-B7C74326B147}"/>
              </a:ext>
            </a:extLst>
          </p:cNvPr>
          <p:cNvSpPr txBox="1"/>
          <p:nvPr/>
        </p:nvSpPr>
        <p:spPr>
          <a:xfrm>
            <a:off x="4810959" y="1273818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0.8</a:t>
            </a:r>
            <a:endParaRPr kumimoji="1" lang="ja-JP" altLang="en-US" sz="14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ADB6AD7-518F-4421-ACE6-8435C15ED03A}"/>
              </a:ext>
            </a:extLst>
          </p:cNvPr>
          <p:cNvSpPr txBox="1"/>
          <p:nvPr/>
        </p:nvSpPr>
        <p:spPr>
          <a:xfrm>
            <a:off x="5352863" y="1272214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0.9</a:t>
            </a:r>
            <a:endParaRPr kumimoji="1" lang="ja-JP" altLang="en-US" sz="14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806E163-AC5B-4313-9552-B8C8A266CDE2}"/>
              </a:ext>
            </a:extLst>
          </p:cNvPr>
          <p:cNvSpPr txBox="1"/>
          <p:nvPr/>
        </p:nvSpPr>
        <p:spPr>
          <a:xfrm>
            <a:off x="5893849" y="1275221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1.0</a:t>
            </a:r>
            <a:endParaRPr kumimoji="1" lang="ja-JP" altLang="en-US" sz="14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EE5789F-CF2F-4789-8B4C-C40809CD8CCF}"/>
              </a:ext>
            </a:extLst>
          </p:cNvPr>
          <p:cNvSpPr txBox="1"/>
          <p:nvPr/>
        </p:nvSpPr>
        <p:spPr>
          <a:xfrm>
            <a:off x="4194466" y="896151"/>
            <a:ext cx="56457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Microsoft Sans Serif" panose="020B0604020202020204" pitchFamily="34" charset="0"/>
                <a:cs typeface="Microsoft Sans Serif" panose="020B0604020202020204" pitchFamily="34" charset="0"/>
              </a:rPr>
              <a:t>AUC</a:t>
            </a:r>
            <a:endParaRPr kumimoji="1" lang="ja-JP" altLang="en-US" sz="1400" b="1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FB4286E-9E05-4473-A31F-AAE0E6A69754}"/>
              </a:ext>
            </a:extLst>
          </p:cNvPr>
          <p:cNvSpPr txBox="1"/>
          <p:nvPr/>
        </p:nvSpPr>
        <p:spPr>
          <a:xfrm>
            <a:off x="2036021" y="1759917"/>
            <a:ext cx="53572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- 64</a:t>
            </a:r>
            <a:endParaRPr kumimoji="1" lang="ja-JP" altLang="en-US" sz="16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B336690-6262-4582-BD9F-6E356F85B83E}"/>
              </a:ext>
            </a:extLst>
          </p:cNvPr>
          <p:cNvSpPr txBox="1"/>
          <p:nvPr/>
        </p:nvSpPr>
        <p:spPr>
          <a:xfrm>
            <a:off x="1626166" y="2304774"/>
            <a:ext cx="96856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65 </a:t>
            </a:r>
            <a:r>
              <a:rPr lang="en-US" altLang="ja-JP" sz="20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– </a:t>
            </a:r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69</a:t>
            </a:r>
            <a:endParaRPr kumimoji="1" lang="ja-JP" altLang="en-US" sz="16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AF3DC65-AE15-462F-886F-32B7CCEB5F33}"/>
              </a:ext>
            </a:extLst>
          </p:cNvPr>
          <p:cNvSpPr txBox="1"/>
          <p:nvPr/>
        </p:nvSpPr>
        <p:spPr>
          <a:xfrm>
            <a:off x="1761907" y="2954395"/>
            <a:ext cx="8098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70 </a:t>
            </a:r>
            <a:r>
              <a:rPr lang="en-US" altLang="ja-JP" sz="16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– 74</a:t>
            </a:r>
            <a:endParaRPr kumimoji="1" lang="ja-JP" altLang="en-US" sz="16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5837B08-7880-43A6-90C7-2E791E5072D6}"/>
              </a:ext>
            </a:extLst>
          </p:cNvPr>
          <p:cNvSpPr txBox="1"/>
          <p:nvPr/>
        </p:nvSpPr>
        <p:spPr>
          <a:xfrm>
            <a:off x="1761908" y="3576270"/>
            <a:ext cx="8098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75 </a:t>
            </a:r>
            <a:r>
              <a:rPr lang="en-US" altLang="ja-JP" sz="16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– 79</a:t>
            </a:r>
            <a:endParaRPr kumimoji="1" lang="ja-JP" altLang="en-US" sz="16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C8C71B7-54C0-4D52-9515-0D38BBF30DA4}"/>
              </a:ext>
            </a:extLst>
          </p:cNvPr>
          <p:cNvSpPr txBox="1"/>
          <p:nvPr/>
        </p:nvSpPr>
        <p:spPr>
          <a:xfrm>
            <a:off x="1761908" y="4211045"/>
            <a:ext cx="8098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80 </a:t>
            </a:r>
            <a:r>
              <a:rPr lang="en-US" altLang="ja-JP" sz="16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– 84</a:t>
            </a:r>
            <a:endParaRPr kumimoji="1" lang="ja-JP" altLang="en-US" sz="16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4AD4AD3-3916-4B02-ACB9-D5FF30C53163}"/>
              </a:ext>
            </a:extLst>
          </p:cNvPr>
          <p:cNvSpPr txBox="1"/>
          <p:nvPr/>
        </p:nvSpPr>
        <p:spPr>
          <a:xfrm>
            <a:off x="1761908" y="4799111"/>
            <a:ext cx="8098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85 </a:t>
            </a:r>
            <a:r>
              <a:rPr lang="en-US" altLang="ja-JP" sz="1600" dirty="0">
                <a:effectLst/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– 89</a:t>
            </a:r>
            <a:endParaRPr kumimoji="1" lang="ja-JP" altLang="en-US" sz="16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7C547C2-56FC-4E77-8D25-DD1C6E15605E}"/>
              </a:ext>
            </a:extLst>
          </p:cNvPr>
          <p:cNvSpPr txBox="1"/>
          <p:nvPr/>
        </p:nvSpPr>
        <p:spPr>
          <a:xfrm>
            <a:off x="1779501" y="5412068"/>
            <a:ext cx="7312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90</a:t>
            </a:r>
            <a:r>
              <a:rPr kumimoji="1" lang="ja-JP" altLang="en-US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 </a:t>
            </a:r>
            <a:r>
              <a:rPr kumimoji="1" lang="en-US" altLang="ja-JP" sz="1600" dirty="0">
                <a:latin typeface="Microsoft Sans Serif" panose="020B0604020202020204" pitchFamily="34" charset="0"/>
                <a:ea typeface="Microsoft Sans Serif" panose="020B0604020202020204" pitchFamily="34" charset="0"/>
                <a:cs typeface="Microsoft Sans Serif" panose="020B0604020202020204" pitchFamily="34" charset="0"/>
              </a:rPr>
              <a:t>-</a:t>
            </a:r>
            <a:endParaRPr kumimoji="1" lang="ja-JP" altLang="en-US" sz="1600" dirty="0">
              <a:latin typeface="Microsoft Sans Serif" panose="020B0604020202020204" pitchFamily="34" charset="0"/>
              <a:cs typeface="Microsoft Sans Serif" panose="020B0604020202020204" pitchFamily="34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5881C04-1360-486C-AFE5-15CA504D128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874" t="2337" r="2792" b="44075"/>
          <a:stretch/>
        </p:blipFill>
        <p:spPr>
          <a:xfrm rot="5400000">
            <a:off x="2333098" y="2051162"/>
            <a:ext cx="4364406" cy="3344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755995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</TotalTime>
  <Words>236</Words>
  <Application>Microsoft Office PowerPoint</Application>
  <PresentationFormat>A4 210 x 297 mm</PresentationFormat>
  <Paragraphs>27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Arial</vt:lpstr>
      <vt:lpstr>Calibri</vt:lpstr>
      <vt:lpstr>Calibri Light</vt:lpstr>
      <vt:lpstr>Century</vt:lpstr>
      <vt:lpstr>Microsoft Sans Serif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go Masaki</dc:creator>
  <cp:lastModifiedBy>Tago Masaki</cp:lastModifiedBy>
  <cp:revision>12</cp:revision>
  <dcterms:created xsi:type="dcterms:W3CDTF">2021-04-07T23:19:43Z</dcterms:created>
  <dcterms:modified xsi:type="dcterms:W3CDTF">2022-01-22T09:47:20Z</dcterms:modified>
</cp:coreProperties>
</file>